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1" r:id="rId3"/>
    <p:sldId id="273" r:id="rId4"/>
    <p:sldId id="275" r:id="rId5"/>
    <p:sldId id="276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2016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38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587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207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784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659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003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005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899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57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728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780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1F182-9142-47FD-B435-3A172DEDF057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061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microsoft.com/office/2007/relationships/hdphoto" Target="../media/hdphoto3.wdp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microsoft.com/office/2007/relationships/hdphoto" Target="../media/hdphoto6.wdp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E691399C-DE61-4269-A390-335E51F4AEFA}"/>
              </a:ext>
            </a:extLst>
          </p:cNvPr>
          <p:cNvGrpSpPr/>
          <p:nvPr/>
        </p:nvGrpSpPr>
        <p:grpSpPr>
          <a:xfrm>
            <a:off x="2845348" y="98424"/>
            <a:ext cx="5434039" cy="3749831"/>
            <a:chOff x="3256828" y="158905"/>
            <a:chExt cx="5434039" cy="3749831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4774DDB7-6F79-4668-83A7-2FDCF12901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72859" t="35925" r="335" b="38967"/>
            <a:stretch/>
          </p:blipFill>
          <p:spPr>
            <a:xfrm flipH="1">
              <a:off x="3256828" y="158905"/>
              <a:ext cx="5434039" cy="3749831"/>
            </a:xfrm>
            <a:prstGeom prst="rect">
              <a:avLst/>
            </a:prstGeom>
          </p:spPr>
        </p:pic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4DF40FFE-2807-4F42-9185-5707B1CB5AF0}"/>
                </a:ext>
              </a:extLst>
            </p:cNvPr>
            <p:cNvGrpSpPr/>
            <p:nvPr/>
          </p:nvGrpSpPr>
          <p:grpSpPr>
            <a:xfrm>
              <a:off x="4922876" y="257134"/>
              <a:ext cx="1751766" cy="570274"/>
              <a:chOff x="4922876" y="257134"/>
              <a:chExt cx="1751766" cy="570274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8A83C33-A4F3-4ACE-A59C-C3BB1F6F3982}"/>
                  </a:ext>
                </a:extLst>
              </p:cNvPr>
              <p:cNvSpPr txBox="1"/>
              <p:nvPr/>
            </p:nvSpPr>
            <p:spPr>
              <a:xfrm flipH="1">
                <a:off x="4922876" y="573492"/>
                <a:ext cx="74978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P: IgG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8507583-B61F-4860-8A93-886423FB59C9}"/>
                  </a:ext>
                </a:extLst>
              </p:cNvPr>
              <p:cNvSpPr txBox="1"/>
              <p:nvPr/>
            </p:nvSpPr>
            <p:spPr>
              <a:xfrm flipH="1">
                <a:off x="5469596" y="572078"/>
                <a:ext cx="64949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RT2</a:t>
                </a:r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F15C4CD9-5566-4D4C-8447-FF000EA9F36A}"/>
                  </a:ext>
                </a:extLst>
              </p:cNvPr>
              <p:cNvCxnSpPr/>
              <p:nvPr/>
            </p:nvCxnSpPr>
            <p:spPr>
              <a:xfrm>
                <a:off x="5062037" y="533856"/>
                <a:ext cx="92704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9A8F985-0169-4EF2-B223-FCB4B0D4FD3C}"/>
                  </a:ext>
                </a:extLst>
              </p:cNvPr>
              <p:cNvSpPr txBox="1"/>
              <p:nvPr/>
            </p:nvSpPr>
            <p:spPr>
              <a:xfrm flipH="1">
                <a:off x="4999388" y="257134"/>
                <a:ext cx="16752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WT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330EF45-36A2-4550-8BEB-A531129FE109}"/>
                </a:ext>
              </a:extLst>
            </p:cNvPr>
            <p:cNvSpPr txBox="1"/>
            <p:nvPr/>
          </p:nvSpPr>
          <p:spPr>
            <a:xfrm flipH="1">
              <a:off x="6858980" y="580068"/>
              <a:ext cx="11584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5768BF3B-0BF4-4F67-8415-BBE710326A2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12" t="51017" r="20954" b="32164"/>
          <a:stretch/>
        </p:blipFill>
        <p:spPr>
          <a:xfrm flipH="1">
            <a:off x="3377007" y="3470994"/>
            <a:ext cx="5170599" cy="3432362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2CA158BB-41DF-4E45-AC1F-6E27ADE6497E}"/>
              </a:ext>
            </a:extLst>
          </p:cNvPr>
          <p:cNvSpPr txBox="1"/>
          <p:nvPr/>
        </p:nvSpPr>
        <p:spPr>
          <a:xfrm>
            <a:off x="1673760" y="27955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</a:p>
        </p:txBody>
      </p:sp>
    </p:spTree>
    <p:extLst>
      <p:ext uri="{BB962C8B-B14F-4D97-AF65-F5344CB8AC3E}">
        <p14:creationId xmlns:p14="http://schemas.microsoft.com/office/powerpoint/2010/main" val="1882208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36C49B8-1F1B-420F-8E66-97472882A3DE}"/>
              </a:ext>
            </a:extLst>
          </p:cNvPr>
          <p:cNvGrpSpPr/>
          <p:nvPr/>
        </p:nvGrpSpPr>
        <p:grpSpPr>
          <a:xfrm>
            <a:off x="3360837" y="381354"/>
            <a:ext cx="4230653" cy="2975853"/>
            <a:chOff x="3093857" y="208428"/>
            <a:chExt cx="4230653" cy="29758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6519915-6C03-4E87-87E6-B4E4E74A21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85" t="74557" r="15491" b="1846"/>
            <a:stretch/>
          </p:blipFill>
          <p:spPr>
            <a:xfrm rot="10800000" flipH="1">
              <a:off x="3093857" y="742335"/>
              <a:ext cx="3789450" cy="2441946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FE9F91E-A01F-4545-A62C-422957A19EF0}"/>
                </a:ext>
              </a:extLst>
            </p:cNvPr>
            <p:cNvGrpSpPr/>
            <p:nvPr/>
          </p:nvGrpSpPr>
          <p:grpSpPr>
            <a:xfrm>
              <a:off x="4143266" y="208428"/>
              <a:ext cx="3181244" cy="573582"/>
              <a:chOff x="3680417" y="841389"/>
              <a:chExt cx="3181244" cy="573582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C461B8A-B0FE-49B7-B5BC-A916A7D89905}"/>
                  </a:ext>
                </a:extLst>
              </p:cNvPr>
              <p:cNvSpPr txBox="1"/>
              <p:nvPr/>
            </p:nvSpPr>
            <p:spPr>
              <a:xfrm flipH="1">
                <a:off x="3680417" y="841389"/>
                <a:ext cx="31812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P: anti-Acetyl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A2BD0F6D-77BB-4224-90A0-B3CB7606D682}"/>
                  </a:ext>
                </a:extLst>
              </p:cNvPr>
              <p:cNvGrpSpPr/>
              <p:nvPr/>
            </p:nvGrpSpPr>
            <p:grpSpPr>
              <a:xfrm>
                <a:off x="3743172" y="878288"/>
                <a:ext cx="2730534" cy="536683"/>
                <a:chOff x="3870068" y="852238"/>
                <a:chExt cx="2730534" cy="536683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FA15886D-D29D-4C28-A9CF-D4426CBE2686}"/>
                    </a:ext>
                  </a:extLst>
                </p:cNvPr>
                <p:cNvSpPr txBox="1"/>
                <p:nvPr/>
              </p:nvSpPr>
              <p:spPr>
                <a:xfrm flipH="1">
                  <a:off x="5519911" y="861863"/>
                  <a:ext cx="56092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EE78B548-CCBA-4DAB-995C-717D4FFE32D4}"/>
                    </a:ext>
                  </a:extLst>
                </p:cNvPr>
                <p:cNvSpPr txBox="1"/>
                <p:nvPr/>
              </p:nvSpPr>
              <p:spPr>
                <a:xfrm flipH="1">
                  <a:off x="5739794" y="1120808"/>
                  <a:ext cx="860808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T2</a:t>
                  </a:r>
                  <a:r>
                    <a:rPr lang="en-US" sz="105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</a:t>
                  </a:r>
                </a:p>
              </p:txBody>
            </p: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D7746B0B-3897-4B35-A6CB-31723375B32B}"/>
                    </a:ext>
                  </a:extLst>
                </p:cNvPr>
                <p:cNvCxnSpPr/>
                <p:nvPr/>
              </p:nvCxnSpPr>
              <p:spPr>
                <a:xfrm flipH="1">
                  <a:off x="5482093" y="1117758"/>
                  <a:ext cx="603909" cy="498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417B4432-2831-4640-B80F-BDEFC30F28A5}"/>
                    </a:ext>
                  </a:extLst>
                </p:cNvPr>
                <p:cNvCxnSpPr/>
                <p:nvPr/>
              </p:nvCxnSpPr>
              <p:spPr>
                <a:xfrm flipH="1" flipV="1">
                  <a:off x="4910862" y="1118804"/>
                  <a:ext cx="300760" cy="252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544FAF92-303E-4E7F-A7E8-052296FDFA7F}"/>
                    </a:ext>
                  </a:extLst>
                </p:cNvPr>
                <p:cNvSpPr txBox="1"/>
                <p:nvPr/>
              </p:nvSpPr>
              <p:spPr>
                <a:xfrm flipH="1">
                  <a:off x="4814865" y="852238"/>
                  <a:ext cx="116419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P: IgG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7158A129-0258-454E-9597-71CEA2EF8EAE}"/>
                    </a:ext>
                  </a:extLst>
                </p:cNvPr>
                <p:cNvSpPr txBox="1"/>
                <p:nvPr/>
              </p:nvSpPr>
              <p:spPr>
                <a:xfrm flipH="1">
                  <a:off x="5477344" y="1123863"/>
                  <a:ext cx="719343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  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D72EA121-9BAB-4BD0-9346-16A95319B9FC}"/>
                    </a:ext>
                  </a:extLst>
                </p:cNvPr>
                <p:cNvSpPr txBox="1"/>
                <p:nvPr/>
              </p:nvSpPr>
              <p:spPr>
                <a:xfrm flipH="1">
                  <a:off x="4247574" y="1122325"/>
                  <a:ext cx="889992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T2</a:t>
                  </a:r>
                  <a:r>
                    <a:rPr lang="en-US" sz="105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464B58C2-448B-4E97-9651-E1974DF496BD}"/>
                    </a:ext>
                  </a:extLst>
                </p:cNvPr>
                <p:cNvSpPr txBox="1"/>
                <p:nvPr/>
              </p:nvSpPr>
              <p:spPr>
                <a:xfrm flipH="1">
                  <a:off x="3870068" y="1123129"/>
                  <a:ext cx="485943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ED8C9E3D-56CF-46E3-9E72-B892F5F5BA13}"/>
                    </a:ext>
                  </a:extLst>
                </p:cNvPr>
                <p:cNvSpPr txBox="1"/>
                <p:nvPr/>
              </p:nvSpPr>
              <p:spPr>
                <a:xfrm flipH="1">
                  <a:off x="4893681" y="1135005"/>
                  <a:ext cx="43610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7BA8A4BA-1C2C-4E0C-AA62-5245AD14BE55}"/>
                    </a:ext>
                  </a:extLst>
                </p:cNvPr>
                <p:cNvCxnSpPr/>
                <p:nvPr/>
              </p:nvCxnSpPr>
              <p:spPr>
                <a:xfrm flipH="1" flipV="1">
                  <a:off x="3929445" y="1117758"/>
                  <a:ext cx="813199" cy="153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pic>
        <p:nvPicPr>
          <p:cNvPr id="21" name="Picture 20">
            <a:extLst>
              <a:ext uri="{FF2B5EF4-FFF2-40B4-BE49-F238E27FC236}">
                <a16:creationId xmlns:a16="http://schemas.microsoft.com/office/drawing/2014/main" id="{EBE99197-5E20-43A5-8B23-45EFB1F3990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29220" t="32716" r="27337" b="43904"/>
          <a:stretch/>
        </p:blipFill>
        <p:spPr>
          <a:xfrm flipH="1">
            <a:off x="3405546" y="3402662"/>
            <a:ext cx="3880061" cy="2108879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19D946C1-3D13-4170-8A0E-C4D2CFD1EC33}"/>
              </a:ext>
            </a:extLst>
          </p:cNvPr>
          <p:cNvSpPr txBox="1"/>
          <p:nvPr/>
        </p:nvSpPr>
        <p:spPr>
          <a:xfrm>
            <a:off x="1673760" y="27955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</a:p>
        </p:txBody>
      </p:sp>
    </p:spTree>
    <p:extLst>
      <p:ext uri="{BB962C8B-B14F-4D97-AF65-F5344CB8AC3E}">
        <p14:creationId xmlns:p14="http://schemas.microsoft.com/office/powerpoint/2010/main" val="1728087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51517496-E45A-457B-9EC9-96BE05C59D9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" t="24613" r="55359" b="39094"/>
          <a:stretch/>
        </p:blipFill>
        <p:spPr>
          <a:xfrm>
            <a:off x="1575503" y="2811033"/>
            <a:ext cx="5117341" cy="2374125"/>
          </a:xfrm>
          <a:prstGeom prst="rect">
            <a:avLst/>
          </a:prstGeom>
        </p:spPr>
      </p:pic>
      <p:pic>
        <p:nvPicPr>
          <p:cNvPr id="8" name="Picture 7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1373E49A-A117-4644-A813-3516E68151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76" t="26608" r="4491" b="34804"/>
          <a:stretch/>
        </p:blipFill>
        <p:spPr>
          <a:xfrm>
            <a:off x="1648284" y="308194"/>
            <a:ext cx="5181200" cy="2677398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E59B789D-C3EA-47DA-9CFB-CB3E5034560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824" t="63644" r="51471" b="6084"/>
          <a:stretch/>
        </p:blipFill>
        <p:spPr>
          <a:xfrm>
            <a:off x="1443823" y="4770604"/>
            <a:ext cx="5590122" cy="190277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46C5004-9F90-45F3-88C7-D5E2300EEDE4}"/>
              </a:ext>
            </a:extLst>
          </p:cNvPr>
          <p:cNvSpPr txBox="1"/>
          <p:nvPr/>
        </p:nvSpPr>
        <p:spPr>
          <a:xfrm>
            <a:off x="643950" y="217609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</p:spTree>
    <p:extLst>
      <p:ext uri="{BB962C8B-B14F-4D97-AF65-F5344CB8AC3E}">
        <p14:creationId xmlns:p14="http://schemas.microsoft.com/office/powerpoint/2010/main" val="30595530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A0B9B6B2-8CC5-4EC4-95A6-CD21CDCAEE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1000" contrast="45000"/>
                    </a14:imgEffect>
                  </a14:imgLayer>
                </a14:imgProps>
              </a:ext>
            </a:extLst>
          </a:blip>
          <a:srcRect l="7729" t="45344" r="56618" b="24906"/>
          <a:stretch/>
        </p:blipFill>
        <p:spPr>
          <a:xfrm>
            <a:off x="1929644" y="1219856"/>
            <a:ext cx="3024050" cy="223424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594C369-EA46-4DFA-8280-C2B9CF5A991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2000" contrast="38000"/>
                    </a14:imgEffect>
                  </a14:imgLayer>
                </a14:imgProps>
              </a:ext>
            </a:extLst>
          </a:blip>
          <a:srcRect l="34961" t="17835" r="50331" b="66966"/>
          <a:stretch/>
        </p:blipFill>
        <p:spPr>
          <a:xfrm flipH="1">
            <a:off x="1710436" y="3548586"/>
            <a:ext cx="3290351" cy="3035571"/>
          </a:xfrm>
          <a:prstGeom prst="rect">
            <a:avLst/>
          </a:prstGeom>
        </p:spPr>
      </p:pic>
      <p:grpSp>
        <p:nvGrpSpPr>
          <p:cNvPr id="24" name="Group 23">
            <a:extLst>
              <a:ext uri="{FF2B5EF4-FFF2-40B4-BE49-F238E27FC236}">
                <a16:creationId xmlns:a16="http://schemas.microsoft.com/office/drawing/2014/main" id="{4CBA5831-69E1-439B-B544-3352A2C03B32}"/>
              </a:ext>
            </a:extLst>
          </p:cNvPr>
          <p:cNvGrpSpPr/>
          <p:nvPr/>
        </p:nvGrpSpPr>
        <p:grpSpPr>
          <a:xfrm>
            <a:off x="1929644" y="82007"/>
            <a:ext cx="3350012" cy="2198018"/>
            <a:chOff x="1270028" y="284611"/>
            <a:chExt cx="3350012" cy="2198018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14928ED4-2EBD-4CFD-A4C6-322FF87465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8000" contrast="37000"/>
                      </a14:imgEffect>
                    </a14:imgLayer>
                  </a14:imgProps>
                </a:ext>
              </a:extLst>
            </a:blip>
            <a:srcRect l="-1845" t="-1534" r="-18683" b="-87242"/>
            <a:stretch/>
          </p:blipFill>
          <p:spPr>
            <a:xfrm flipH="1">
              <a:off x="1270028" y="284611"/>
              <a:ext cx="3181244" cy="2198018"/>
            </a:xfrm>
            <a:prstGeom prst="rect">
              <a:avLst/>
            </a:prstGeom>
          </p:spPr>
        </p:pic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E22343B9-D780-4CFD-92FA-1A20FF4B0716}"/>
                </a:ext>
              </a:extLst>
            </p:cNvPr>
            <p:cNvGrpSpPr/>
            <p:nvPr/>
          </p:nvGrpSpPr>
          <p:grpSpPr>
            <a:xfrm>
              <a:off x="3167377" y="334046"/>
              <a:ext cx="1452663" cy="401184"/>
              <a:chOff x="7272613" y="1505688"/>
              <a:chExt cx="1452663" cy="401184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30869FF-D8D3-4C41-B3FC-8DC3339337BA}"/>
                  </a:ext>
                </a:extLst>
              </p:cNvPr>
              <p:cNvSpPr txBox="1"/>
              <p:nvPr/>
            </p:nvSpPr>
            <p:spPr>
              <a:xfrm>
                <a:off x="7272613" y="1505688"/>
                <a:ext cx="88174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BDDB3C9-1472-4B24-BB7A-6D3F6DDAA8A0}"/>
                  </a:ext>
                </a:extLst>
              </p:cNvPr>
              <p:cNvSpPr txBox="1"/>
              <p:nvPr/>
            </p:nvSpPr>
            <p:spPr>
              <a:xfrm>
                <a:off x="7843533" y="1506762"/>
                <a:ext cx="88174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RT2 siRNA</a:t>
                </a:r>
              </a:p>
            </p:txBody>
          </p:sp>
        </p:grp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8BE9D35F-468E-44DB-A146-21B722E6B355}"/>
              </a:ext>
            </a:extLst>
          </p:cNvPr>
          <p:cNvSpPr txBox="1"/>
          <p:nvPr/>
        </p:nvSpPr>
        <p:spPr>
          <a:xfrm>
            <a:off x="270780" y="286610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</a:p>
        </p:txBody>
      </p:sp>
    </p:spTree>
    <p:extLst>
      <p:ext uri="{BB962C8B-B14F-4D97-AF65-F5344CB8AC3E}">
        <p14:creationId xmlns:p14="http://schemas.microsoft.com/office/powerpoint/2010/main" val="23948224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2BC22A03-A7A7-43C7-BD27-3616C9778C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2000" contrast="35000"/>
                    </a14:imgEffect>
                  </a14:imgLayer>
                </a14:imgProps>
              </a:ext>
            </a:extLst>
          </a:blip>
          <a:srcRect l="16194" t="4303" r="45570" b="60706"/>
          <a:stretch/>
        </p:blipFill>
        <p:spPr>
          <a:xfrm flipH="1">
            <a:off x="2274148" y="104734"/>
            <a:ext cx="3532824" cy="332426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7DBFFB59-9096-4AA3-AD1A-0531E690E47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1000" contrast="35000"/>
                    </a14:imgEffect>
                  </a14:imgLayer>
                </a14:imgProps>
              </a:ext>
            </a:extLst>
          </a:blip>
          <a:srcRect l="26759" t="26894" r="57935" b="49758"/>
          <a:stretch/>
        </p:blipFill>
        <p:spPr>
          <a:xfrm flipH="1">
            <a:off x="2529706" y="3429000"/>
            <a:ext cx="3170646" cy="3324266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A3F892A0-F746-465A-8980-6E2B4D554C28}"/>
              </a:ext>
            </a:extLst>
          </p:cNvPr>
          <p:cNvSpPr txBox="1"/>
          <p:nvPr/>
        </p:nvSpPr>
        <p:spPr>
          <a:xfrm>
            <a:off x="3674158" y="61054"/>
            <a:ext cx="8817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061C457-0A74-485D-9CE0-ECA6B21F9994}"/>
              </a:ext>
            </a:extLst>
          </p:cNvPr>
          <p:cNvSpPr txBox="1"/>
          <p:nvPr/>
        </p:nvSpPr>
        <p:spPr>
          <a:xfrm>
            <a:off x="4245078" y="62128"/>
            <a:ext cx="8817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IRT2 siRN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BE9D35F-468E-44DB-A146-21B722E6B355}"/>
              </a:ext>
            </a:extLst>
          </p:cNvPr>
          <p:cNvSpPr txBox="1"/>
          <p:nvPr/>
        </p:nvSpPr>
        <p:spPr>
          <a:xfrm>
            <a:off x="270780" y="28661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E</a:t>
            </a:r>
          </a:p>
        </p:txBody>
      </p:sp>
    </p:spTree>
    <p:extLst>
      <p:ext uri="{BB962C8B-B14F-4D97-AF65-F5344CB8AC3E}">
        <p14:creationId xmlns:p14="http://schemas.microsoft.com/office/powerpoint/2010/main" val="709858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1</TotalTime>
  <Words>39</Words>
  <Application>Microsoft Office PowerPoint</Application>
  <PresentationFormat>On-screen Show (4:3)</PresentationFormat>
  <Paragraphs>2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 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RT2 interacts with Nrf2 to regulate iron homeostasis and iron-dependent cell death</dc:title>
  <dc:creator>Yang, Xiaoyan</dc:creator>
  <cp:lastModifiedBy>Hossein Ardehali</cp:lastModifiedBy>
  <cp:revision>214</cp:revision>
  <dcterms:created xsi:type="dcterms:W3CDTF">2013-10-29T15:44:39Z</dcterms:created>
  <dcterms:modified xsi:type="dcterms:W3CDTF">2023-01-24T20:30:35Z</dcterms:modified>
</cp:coreProperties>
</file>